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巌 千嶋" userId="13ec93f7efb543d5" providerId="LiveId" clId="{8DDF102C-FC16-44D3-9636-1BF7B7D0053F}"/>
    <pc:docChg chg="undo custSel modSld">
      <pc:chgData name="巌 千嶋" userId="13ec93f7efb543d5" providerId="LiveId" clId="{8DDF102C-FC16-44D3-9636-1BF7B7D0053F}" dt="2024-11-03T06:47:33.866" v="15" actId="1036"/>
      <pc:docMkLst>
        <pc:docMk/>
      </pc:docMkLst>
      <pc:sldChg chg="modSp mod">
        <pc:chgData name="巌 千嶋" userId="13ec93f7efb543d5" providerId="LiveId" clId="{8DDF102C-FC16-44D3-9636-1BF7B7D0053F}" dt="2024-11-03T06:47:33.866" v="15" actId="1036"/>
        <pc:sldMkLst>
          <pc:docMk/>
          <pc:sldMk cId="2831148084" sldId="256"/>
        </pc:sldMkLst>
        <pc:graphicFrameChg chg="mod modGraphic">
          <ac:chgData name="巌 千嶋" userId="13ec93f7efb543d5" providerId="LiveId" clId="{8DDF102C-FC16-44D3-9636-1BF7B7D0053F}" dt="2024-11-03T06:47:33.866" v="15" actId="1036"/>
          <ac:graphicFrameMkLst>
            <pc:docMk/>
            <pc:sldMk cId="2831148084" sldId="256"/>
            <ac:graphicFrameMk id="5" creationId="{BFCFD3D5-043E-E6DF-49A5-39C4A599A0CA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537E1B-CC33-C4D1-0670-10DF88FEE6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A348087-EE69-0A19-9C13-1E229B9A62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3D3939-E3B7-BDAA-1A14-782C6176D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9BEC6E-C619-381B-2423-AE1CAA69F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CC31A5-962A-1E4E-180C-1F2F81A3A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63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A656C1-C95D-112A-61FE-3E7F2EB8C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CF276D-EF6B-43B8-180B-222668B231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063588-6AE2-FB32-EFAC-5534C6132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E3A360-1863-6ABE-0DC6-4F8CA8B6B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9C1064-2A46-DD42-FB7F-DF47FC12F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9598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97F0DB5-0FC5-DD5A-CB2F-67334657AF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AE84B7D-C954-52D9-DBC1-0C3E689ADE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6D2CBC-C0C4-D903-46F5-5F6DB764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5F19D-2BCA-BFD7-F533-DD67ACA02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46AC92-7C58-596F-6BAB-6A614C616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959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6AB5D6-8006-BF24-5792-15821434B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342AB32-39A7-58B3-CEE4-44C550975D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74DE54-0730-53A0-86A3-87836C9CA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D5B354-67BF-FA30-2A67-D269899FD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F9500D-43EA-D901-F946-197D2FD16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274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F820ED-9C1E-944E-0BD8-C4E5D7D11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026D326-3884-BDB5-6316-B31FEBD20E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C38C9C-DC7C-E369-4C36-618E123BD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CDC85A-CCDC-6B28-D827-3FDB472AC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102050-43B8-05F7-0E09-CBB99D07E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035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E3CAEC-9BE3-B646-2F8D-141073264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36EB5C1-1E05-BAE4-5350-D22C0260F7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0E41F8-2CFE-8229-73ED-94F730DC62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969786B-EDE5-8679-60CF-D294DCD8E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9EFDD6-CBA7-10B0-1FB5-76DDD200D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43861F-DDBB-B4B4-8027-458B56873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678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80774A-3696-1602-03FE-F63E39AFA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11E68F-60A1-2445-AF6E-EE7767686E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9ED186F-66A0-AB05-7DE7-43193F6ECB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2AF34A5-1C2D-8EFF-1515-E8BE102A42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297FC78-4A95-8C72-AD2D-728CD8E97F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34BA64B-E89A-F674-4A54-38507BE7E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FFD31D9-1491-A0E5-6BFB-A0D69A8E0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DDCCF26-8CC3-0DF4-D41E-0A6F0E751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133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49CAB2-875A-92C1-27AC-2D550AD0A4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F06C3F9-A0FB-A69C-EF95-FD3ED3707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A498FD2-C964-F128-C445-3E3FBB45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18DAFA9-D762-761C-2693-A74BBC980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768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76DA06C-AE20-B94D-C48D-151878A87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E8AFAA8-EA21-AD34-E867-CA8B491D2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6394D2F-DCBA-43A7-9B19-43E8C9AA7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20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5AD49F-803C-78EB-D2EC-62B915A48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E90A231-3B3A-1954-4D60-8E0DBE4919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9D11546-B6EA-662F-DD06-60F158E8F4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B8321F-9EE9-B2FE-80E9-E0B8FF0F4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53F8EC-ADF8-20A7-224C-F1DE38B73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22808C8-B92D-2DE8-52A5-9E7D30706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439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A0B1F6-2521-8968-101E-6D4755352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584F9FE-650A-00FB-5DEF-5B72F8E846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D2F97B5-E667-245D-A32F-0D2C75A7B0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E80579F-DB07-E7AC-4817-261B53C7F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66A8CA-49CA-B630-C98D-07099E57F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5646C4-BED5-A8A9-917A-ED86AFBCF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108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3B4832-864D-ED24-25A6-04C34AD94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1790FC9-5FBD-BFB3-679B-C5CFFEACF8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652130-60D5-2747-A4D8-6B71D0DF8C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439E94-7758-4D40-9FA3-20FFE6FB59D1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E63916-918C-5C52-3483-C5887FA162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BC4157-7F45-AA70-258D-A1A1518209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F501F7-27AA-4AE7-A3B1-24842CC18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797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FCFD3D5-043E-E6DF-49A5-39C4A599A0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5576013"/>
              </p:ext>
            </p:extLst>
          </p:nvPr>
        </p:nvGraphicFramePr>
        <p:xfrm>
          <a:off x="1344166" y="184119"/>
          <a:ext cx="9308590" cy="6415540"/>
        </p:xfrm>
        <a:graphic>
          <a:graphicData uri="http://schemas.openxmlformats.org/drawingml/2006/table">
            <a:tbl>
              <a:tblPr/>
              <a:tblGrid>
                <a:gridCol w="826463">
                  <a:extLst>
                    <a:ext uri="{9D8B030D-6E8A-4147-A177-3AD203B41FA5}">
                      <a16:colId xmlns:a16="http://schemas.microsoft.com/office/drawing/2014/main" val="3519528043"/>
                    </a:ext>
                  </a:extLst>
                </a:gridCol>
                <a:gridCol w="826463">
                  <a:extLst>
                    <a:ext uri="{9D8B030D-6E8A-4147-A177-3AD203B41FA5}">
                      <a16:colId xmlns:a16="http://schemas.microsoft.com/office/drawing/2014/main" val="369274604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3381141736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291193073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2314658843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781638884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988486390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340589673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4221208528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4170385038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538838501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4126721477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1017267562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129381959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1417420797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4191514133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2322989750"/>
                    </a:ext>
                  </a:extLst>
                </a:gridCol>
                <a:gridCol w="478479">
                  <a:extLst>
                    <a:ext uri="{9D8B030D-6E8A-4147-A177-3AD203B41FA5}">
                      <a16:colId xmlns:a16="http://schemas.microsoft.com/office/drawing/2014/main" val="427136584"/>
                    </a:ext>
                  </a:extLst>
                </a:gridCol>
              </a:tblGrid>
              <a:tr h="375420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plementary Table 2. Association between ACE component and risk of mortality after converting age into a squared term. (modified Poisson regression model n=13,174) 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2680059"/>
                  </a:ext>
                </a:extLst>
              </a:tr>
              <a:tr h="1907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n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87777"/>
                  </a:ext>
                </a:extLst>
              </a:tr>
              <a:tr h="19077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9332668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=5,38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0193991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loss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9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6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1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7582559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divorc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4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5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7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0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0029864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mental illness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7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93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0232202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violenc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7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6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3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8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2839687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ysical abus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8064251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 Psychological neglect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1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0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6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554825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sychological abus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4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3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8177001"/>
                  </a:ext>
                </a:extLst>
              </a:tr>
              <a:tr h="1907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omen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0853738"/>
                  </a:ext>
                </a:extLst>
              </a:tr>
              <a:tr h="19077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8229964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=6,348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6650286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loss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9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2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699485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divorc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0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3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8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8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1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2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3151096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mental illness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2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0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7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9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8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7376972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violenc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5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5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2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8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5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0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9156344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ysical abus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9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8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3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1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8288762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 Psychological neglect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2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5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17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9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8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5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5168910"/>
                  </a:ext>
                </a:extLst>
              </a:tr>
              <a:tr h="19077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sychological abuse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4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90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3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8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4553" marR="4553" marT="45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6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0687901"/>
                  </a:ext>
                </a:extLst>
              </a:tr>
              <a:tr h="375420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te. Controlled for age, childhood economical hardship, height, education, equivalized income, longest occupation, smoing, drinking, Disease, depressive symptom, martial status, frequency of meeting friends, social participation, employment status.   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1370027"/>
                  </a:ext>
                </a:extLst>
              </a:tr>
              <a:tr h="35317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 includes ACEs components 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2936234"/>
                  </a:ext>
                </a:extLst>
              </a:tr>
              <a:tr h="379979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1 Includes Crude Model and age and adverse childhood experiences (economic status in childhood, height, educational history) and socioeconomic status in old age (equivalized income, employment status).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3509130"/>
                  </a:ext>
                </a:extLst>
              </a:tr>
              <a:tr h="375420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2 includes Model 2 and health status in old age (hypertension, diabetes, dyslipidemia, heart disease, respiratory disease, cancer) and lifestyle (smoking and alcohol).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3683886"/>
                  </a:ext>
                </a:extLst>
              </a:tr>
              <a:tr h="353175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3 includes Model 3 and social relationships in old age (social participation, frequency of interaction with friends, employment status, marital status). 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4778936"/>
                  </a:ext>
                </a:extLst>
              </a:tr>
              <a:tr h="353175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: Adverse Childhood Experiences, IRR: Incidence Rate Ratio, CI: Confidence Interval  </a:t>
                      </a: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53" marR="4553" marT="455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61348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31148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05</Words>
  <Application>Microsoft Office PowerPoint</Application>
  <PresentationFormat>ワイド画面</PresentationFormat>
  <Paragraphs>28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巌 千嶋</dc:creator>
  <cp:lastModifiedBy>巌 千嶋</cp:lastModifiedBy>
  <cp:revision>1</cp:revision>
  <dcterms:created xsi:type="dcterms:W3CDTF">2024-11-03T05:35:20Z</dcterms:created>
  <dcterms:modified xsi:type="dcterms:W3CDTF">2024-11-03T06:47:44Z</dcterms:modified>
</cp:coreProperties>
</file>